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456" y="-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48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926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37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619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76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756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193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220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542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82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90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30464-7351-4AF9-9F44-DDDE67D9DC92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D57FD-B49B-4ED3-8378-67351F1D1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127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13" Type="http://schemas.openxmlformats.org/officeDocument/2006/relationships/image" Target="../media/image8.jpeg"/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12" Type="http://schemas.openxmlformats.org/officeDocument/2006/relationships/image" Target="../media/image7.jpe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image" Target="../media/image6.jpeg"/><Relationship Id="rId5" Type="http://schemas.openxmlformats.org/officeDocument/2006/relationships/image" Target="../media/image3.png"/><Relationship Id="rId10" Type="http://schemas.openxmlformats.org/officeDocument/2006/relationships/image" Target="../media/image5.jpeg"/><Relationship Id="rId4" Type="http://schemas.microsoft.com/office/2007/relationships/hdphoto" Target="../media/hdphoto1.wdp"/><Relationship Id="rId9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ØµÙØ±Ø© Ø°Ø§Øª ØµÙØ©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-152400"/>
            <a:ext cx="1447800" cy="12379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ounded Rectangle 4"/>
          <p:cNvSpPr/>
          <p:nvPr/>
        </p:nvSpPr>
        <p:spPr>
          <a:xfrm>
            <a:off x="228600" y="876522"/>
            <a:ext cx="1600200" cy="647478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timized Solid dispersion of DC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Plus 6"/>
          <p:cNvSpPr/>
          <p:nvPr/>
        </p:nvSpPr>
        <p:spPr>
          <a:xfrm>
            <a:off x="1905000" y="609600"/>
            <a:ext cx="274320" cy="365760"/>
          </a:xfrm>
          <a:prstGeom prst="mathPlus">
            <a:avLst/>
          </a:prstGeom>
          <a:ln w="2540" cap="flat" cmpd="sn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b="1" dirty="0"/>
          </a:p>
        </p:txBody>
      </p:sp>
      <p:sp>
        <p:nvSpPr>
          <p:cNvPr id="8" name="Rounded Rectangle 7"/>
          <p:cNvSpPr/>
          <p:nvPr/>
        </p:nvSpPr>
        <p:spPr>
          <a:xfrm>
            <a:off x="2439212" y="1195030"/>
            <a:ext cx="2088203" cy="428018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-melt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2449751" y="624191"/>
            <a:ext cx="2067126" cy="428018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solv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DT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2428674" y="76200"/>
            <a:ext cx="2067126" cy="428017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rmaburst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00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Notched Right Arrow 11"/>
          <p:cNvSpPr/>
          <p:nvPr/>
        </p:nvSpPr>
        <p:spPr>
          <a:xfrm>
            <a:off x="4724400" y="724561"/>
            <a:ext cx="1143001" cy="189839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pic>
        <p:nvPicPr>
          <p:cNvPr id="13" name="Picture 2" descr="ÙØªÙØ¬Ø© Ø¨Ø­Ø« Ø§ÙØµÙØ± Ø¹Ù âªsingle punch tablet machineâ¬â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-228600"/>
            <a:ext cx="2514600" cy="2004849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Rounded Rectangle 13"/>
          <p:cNvSpPr/>
          <p:nvPr/>
        </p:nvSpPr>
        <p:spPr>
          <a:xfrm>
            <a:off x="6019800" y="1676400"/>
            <a:ext cx="2322798" cy="547629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rect compression method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Notched Right Arrow 14"/>
          <p:cNvSpPr/>
          <p:nvPr/>
        </p:nvSpPr>
        <p:spPr>
          <a:xfrm rot="5400000">
            <a:off x="6972600" y="2494714"/>
            <a:ext cx="514886" cy="134485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16" name="Rounded Rectangle 15"/>
          <p:cNvSpPr/>
          <p:nvPr/>
        </p:nvSpPr>
        <p:spPr>
          <a:xfrm>
            <a:off x="6412846" y="6210522"/>
            <a:ext cx="2121554" cy="571278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timized DCN ODT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Notched Right Arrow 17"/>
          <p:cNvSpPr/>
          <p:nvPr/>
        </p:nvSpPr>
        <p:spPr>
          <a:xfrm rot="10800000">
            <a:off x="5181599" y="5296560"/>
            <a:ext cx="1143001" cy="189839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828800"/>
            <a:ext cx="4191000" cy="152399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20" name="Rounded Rectangle 19"/>
          <p:cNvSpPr/>
          <p:nvPr/>
        </p:nvSpPr>
        <p:spPr>
          <a:xfrm>
            <a:off x="1569389" y="3429000"/>
            <a:ext cx="2209800" cy="5334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tro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ssolution profiles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1850647"/>
              </p:ext>
            </p:extLst>
          </p:nvPr>
        </p:nvGraphicFramePr>
        <p:xfrm>
          <a:off x="304800" y="4115129"/>
          <a:ext cx="3219133" cy="191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r:id="rId8" imgW="6697444" imgH="3305494" progId="Prism6.Document">
                  <p:embed/>
                </p:oleObj>
              </mc:Choice>
              <mc:Fallback>
                <p:oleObj r:id="rId8" imgW="6697444" imgH="3305494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4800" y="4115129"/>
                        <a:ext cx="3219133" cy="1917900"/>
                      </a:xfrm>
                      <a:prstGeom prst="rect">
                        <a:avLst/>
                      </a:prstGeom>
                      <a:noFill/>
                      <a:ln w="3175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Notched Right Arrow 26"/>
          <p:cNvSpPr/>
          <p:nvPr/>
        </p:nvSpPr>
        <p:spPr>
          <a:xfrm rot="12637653">
            <a:off x="4800599" y="3166415"/>
            <a:ext cx="1143001" cy="189839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  <p:sp>
        <p:nvSpPr>
          <p:cNvPr id="28" name="Rounded Rectangle 27"/>
          <p:cNvSpPr/>
          <p:nvPr/>
        </p:nvSpPr>
        <p:spPr>
          <a:xfrm>
            <a:off x="1600200" y="6171978"/>
            <a:ext cx="2209800" cy="533400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inflammatory activity (Rat paw edema metho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Picture 28" descr="C:\Users\shahi\OneDrive\Desktop\New folder (4)\20190505_112012.jpg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85" r="38942" b="28797"/>
          <a:stretch/>
        </p:blipFill>
        <p:spPr bwMode="auto">
          <a:xfrm>
            <a:off x="3600133" y="4102515"/>
            <a:ext cx="1352867" cy="10028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0" name="Picture 29" descr="C:\Users\shahi\OneDrive\Desktop\New folder (4)\20190505_112253 - Copy.jpg"/>
          <p:cNvPicPr/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9" t="2848" r="32534" b="13607"/>
          <a:stretch/>
        </p:blipFill>
        <p:spPr bwMode="auto">
          <a:xfrm>
            <a:off x="3600133" y="5105400"/>
            <a:ext cx="1352867" cy="9144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41" name="Picture 17" descr="C:\Users\shahi\OneDrive\Desktop\Tablet 3.jpg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56" t="9210" r="11931" b="30000"/>
          <a:stretch/>
        </p:blipFill>
        <p:spPr bwMode="auto">
          <a:xfrm>
            <a:off x="6471526" y="4603956"/>
            <a:ext cx="1834274" cy="11872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C:\Users\shahi\OneDrive\Desktop\Tablet 4.jpg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73" t="42197" r="32128" b="16929"/>
          <a:stretch/>
        </p:blipFill>
        <p:spPr bwMode="auto">
          <a:xfrm>
            <a:off x="6406274" y="2895600"/>
            <a:ext cx="1828115" cy="1295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Rounded Rectangle 23"/>
          <p:cNvSpPr/>
          <p:nvPr/>
        </p:nvSpPr>
        <p:spPr>
          <a:xfrm>
            <a:off x="6879253" y="5867400"/>
            <a:ext cx="1045547" cy="253682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de view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ounded Rectangle 24"/>
          <p:cNvSpPr/>
          <p:nvPr/>
        </p:nvSpPr>
        <p:spPr>
          <a:xfrm>
            <a:off x="6924812" y="4280384"/>
            <a:ext cx="923788" cy="215416"/>
          </a:xfrm>
          <a:prstGeom prst="round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 view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8625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3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6.Document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inazeamry9@gmail.com</dc:creator>
  <cp:lastModifiedBy>shahinazeamry9@gmail.com</cp:lastModifiedBy>
  <cp:revision>12</cp:revision>
  <dcterms:created xsi:type="dcterms:W3CDTF">2020-08-03T09:51:53Z</dcterms:created>
  <dcterms:modified xsi:type="dcterms:W3CDTF">2020-08-03T16:47:27Z</dcterms:modified>
</cp:coreProperties>
</file>